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82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16505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92882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91534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60150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9415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49707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46022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2612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89163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97746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14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0A569-418D-4937-8E0C-7968BE75CBB5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030EB-DC1B-4BAE-A52F-A3EB9181C3A6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937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08247A0-1A71-452A-B377-C3487F501C1F}"/>
              </a:ext>
            </a:extLst>
          </p:cNvPr>
          <p:cNvSpPr txBox="1"/>
          <p:nvPr/>
        </p:nvSpPr>
        <p:spPr>
          <a:xfrm>
            <a:off x="-61242" y="-2272"/>
            <a:ext cx="77701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</a:t>
            </a:r>
            <a:r>
              <a:rPr lang="en-US" sz="1200" b="1" smtClean="0"/>
              <a:t>7 Figure S3. </a:t>
            </a:r>
            <a:r>
              <a:rPr lang="en-US" sz="1200" cap="small" dirty="0" err="1"/>
              <a:t>FineStructure</a:t>
            </a:r>
            <a:r>
              <a:rPr lang="en-US" sz="1200" dirty="0"/>
              <a:t> clustering of eastern and southeastern European sheep breeds. The color of each bin in the matrix indicates the number of “genomic chunks” copied from a donor (columns) to a recipient individual (row).</a:t>
            </a:r>
            <a:endParaRPr lang="nl-NL" sz="12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AECEA3EB-160A-4569-8100-F74E6F0E1F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00"/>
          <a:stretch/>
        </p:blipFill>
        <p:spPr>
          <a:xfrm>
            <a:off x="1489888" y="680779"/>
            <a:ext cx="7620000" cy="617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3588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/>
  <cp:revision>2</cp:revision>
  <dcterms:created xsi:type="dcterms:W3CDTF">2020-02-17T16:02:20Z</dcterms:created>
  <dcterms:modified xsi:type="dcterms:W3CDTF">2020-04-24T20:41:07Z</dcterms:modified>
</cp:coreProperties>
</file>